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85F21-8A86-46CB-AD6A-75D4FA048A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F49441-1BEE-4BC0-BD96-39DC3663DA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6B6A7-FA7E-4D11-8C3C-D61C258CD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0D697-903F-4523-B363-14BDDA25D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F07C1B-CAA1-4FC8-BB4D-3F773FEDB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416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227BB-CD50-4F12-8DCE-75BE3707C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425186-9C90-4BA0-A173-972AA06F91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7FAD6A-E1BF-4A1D-8FAB-8FF96B5E1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22007-D463-4DA7-B706-5BA29AA00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13040-F7C9-49F9-8056-8A7D71A69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520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8B7895-9FDD-45A3-AE0E-7E865EC414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6C1F95-8408-4905-ACFB-8DC605BFE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1B53BF-0E37-4B1A-8286-8DFCA5BA9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82697E-28CD-4727-8EF0-550B41336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3C4EB-BF64-427D-8D32-6C6846DB5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36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4698B9-3DAE-4514-B89B-15667C4288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BB5C86-500A-4469-9B03-B9559460A5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05E28C-F61F-441A-928B-8A23452F0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40B7D-23F6-45FA-B28C-C6DED3DA4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6D496-0082-4AA1-B489-6E5DA290E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91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7B0D5-2422-4FD5-942B-DBB0082AA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0805E7-8370-47E2-8FCD-A75CE4E41A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5C5140-FBB2-48E4-BEBC-1865E0163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A44C1B-6245-417D-BEF5-E6C160A4E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4A4D0-9212-457E-A86B-368ACA756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196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A0F08-F2B4-4C15-BBC3-D28A15083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A9544C-56ED-49C1-A1A2-0D19706B73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70959-5764-4800-BED7-0AE070C9FE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D2AACC-CEEE-4648-82B3-88BFC7686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0A696F-7BBC-4E13-B695-1B303BB83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BA27DB-9C21-4523-9186-E33A96EB3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383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2132F-AC78-4923-8030-E1DC26847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67884-3269-45BB-AA0E-156F78C5C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877893-6558-4401-B3D1-6E74677AB0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0E57EE-7AA0-4AAB-A17B-EA2D3E7044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61548B-35F2-4C59-9B9E-F20DD1EC54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CB5326-FB50-487E-9BBD-CE8EB8FBC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AFB3AA-F61E-4634-B8B6-AD64F8693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26C01F-804F-49A9-9DA6-15F8E25AD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402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AAF45E-218D-48AF-9F9B-4A5CCC8DB1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05C77D-5970-4215-A253-5CC76E863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CC1902-678C-451D-8483-974E048BD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31CD80-C97F-450F-AD8B-0FF95291A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039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C77881-0B72-4BFB-84BD-1A286E671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A15FA1-D143-4202-A0E7-778249E3E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17D6F9-C0D0-41DF-9908-A07B5BF01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918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CA6B84-DB62-4972-9792-0A8EB3FBBE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39B41-818C-4617-8A80-F8683C2401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CB141E-ED3F-4241-AEA5-F590B097C0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5FF951-AAB1-4599-BC2E-610564A66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8CA06F-873C-47A3-BA3A-9069134D7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3A832B-65EF-4E11-A0B6-8710E58A1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200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3A427B-CC14-4199-AB69-1C241EBBE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0425CA-0408-4988-8ACA-DB1B85E5A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265DB9-996C-4E63-AD73-AB3407FC3C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22AB72-B8C4-4D9E-BAED-E73208E99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95F4C6-D56D-4AEA-9C5F-683F10234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E85B7F-4E9C-4BF7-8F69-8C6DA1D96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792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69B933-FB0E-4338-A3AF-AAA46540B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464539-F36C-4C20-BBD5-B5FB383F8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9AD68-1AF8-4397-B0B3-A57D1CBF15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0FFB4-6D68-4248-9D06-7E3214B55404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3415F3-3814-4AA4-B2AE-60918C54C7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E80B82-8F11-4B55-9CCC-FA236BDEF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62E683-262D-4EC5-9412-30670AEDBD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46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tiff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jpe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940961" y="119530"/>
          <a:ext cx="8296255" cy="654371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59251">
                  <a:extLst>
                    <a:ext uri="{9D8B030D-6E8A-4147-A177-3AD203B41FA5}">
                      <a16:colId xmlns:a16="http://schemas.microsoft.com/office/drawing/2014/main" val="2264929770"/>
                    </a:ext>
                  </a:extLst>
                </a:gridCol>
                <a:gridCol w="1659251">
                  <a:extLst>
                    <a:ext uri="{9D8B030D-6E8A-4147-A177-3AD203B41FA5}">
                      <a16:colId xmlns:a16="http://schemas.microsoft.com/office/drawing/2014/main" val="1698846686"/>
                    </a:ext>
                  </a:extLst>
                </a:gridCol>
                <a:gridCol w="1659251">
                  <a:extLst>
                    <a:ext uri="{9D8B030D-6E8A-4147-A177-3AD203B41FA5}">
                      <a16:colId xmlns:a16="http://schemas.microsoft.com/office/drawing/2014/main" val="2434284237"/>
                    </a:ext>
                  </a:extLst>
                </a:gridCol>
                <a:gridCol w="1659251">
                  <a:extLst>
                    <a:ext uri="{9D8B030D-6E8A-4147-A177-3AD203B41FA5}">
                      <a16:colId xmlns:a16="http://schemas.microsoft.com/office/drawing/2014/main" val="2722501277"/>
                    </a:ext>
                  </a:extLst>
                </a:gridCol>
                <a:gridCol w="1659251">
                  <a:extLst>
                    <a:ext uri="{9D8B030D-6E8A-4147-A177-3AD203B41FA5}">
                      <a16:colId xmlns:a16="http://schemas.microsoft.com/office/drawing/2014/main" val="926903359"/>
                    </a:ext>
                  </a:extLst>
                </a:gridCol>
              </a:tblGrid>
              <a:tr h="601437"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POD 0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POD18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POD 35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POD56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37245396"/>
                  </a:ext>
                </a:extLst>
              </a:tr>
              <a:tr h="1298110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1e2 disc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56816736"/>
                  </a:ext>
                </a:extLst>
              </a:tr>
              <a:tr h="1383030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1e2 cortical allograft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6216577"/>
                  </a:ext>
                </a:extLst>
              </a:tr>
              <a:tr h="1543050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1e2 cancellous allograft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7147625"/>
                  </a:ext>
                </a:extLst>
              </a:tr>
              <a:tr h="1360170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Sterile </a:t>
                      </a:r>
                    </a:p>
                    <a:p>
                      <a:pPr algn="ctr"/>
                      <a:r>
                        <a:rPr lang="en-US" sz="800" b="0" i="1" dirty="0">
                          <a:latin typeface="Arial"/>
                          <a:cs typeface="Arial"/>
                        </a:rPr>
                        <a:t>control</a:t>
                      </a:r>
                    </a:p>
                    <a:p>
                      <a:pPr algn="ctr"/>
                      <a:endParaRPr lang="en-US" sz="800" b="0" i="1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6035331"/>
                  </a:ext>
                </a:extLst>
              </a:tr>
              <a:tr h="357916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latin typeface="Arial"/>
                          <a:cs typeface="Arial"/>
                        </a:rPr>
                        <a:t>Supplemental Figure 6. Implant Radiographs. Radiographic analysis of inoculum 1*10</a:t>
                      </a:r>
                      <a:r>
                        <a:rPr lang="en-US" sz="800" b="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800" b="0" dirty="0">
                          <a:latin typeface="Arial"/>
                          <a:cs typeface="Arial"/>
                        </a:rPr>
                        <a:t> CFU and sterile control onto stainless steel disc, cortical allograft, and cancellous allograft at POD 0, POD 18, POD 35, and POD 56.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68580" marR="68580" marT="34290" marB="3429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4981870"/>
                  </a:ext>
                </a:extLst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64777" y="4823321"/>
            <a:ext cx="1359130" cy="14785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351393" y="4819914"/>
            <a:ext cx="1475393" cy="148212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14022" y="4819915"/>
            <a:ext cx="1384220" cy="148212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4777" y="2059071"/>
            <a:ext cx="1359130" cy="133642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51393" y="2059070"/>
            <a:ext cx="1475393" cy="1338942"/>
          </a:xfrm>
          <a:prstGeom prst="rect">
            <a:avLst/>
          </a:prstGeom>
        </p:spPr>
      </p:pic>
      <p:pic>
        <p:nvPicPr>
          <p:cNvPr id="10" name="Content Placeholder 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14022" y="2059070"/>
            <a:ext cx="1384220" cy="133642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837198" y="4819913"/>
            <a:ext cx="1255136" cy="148194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37198" y="2059070"/>
            <a:ext cx="1255136" cy="133642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BB94205-C57C-4380-BB27-C9FB8252A2E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4778" y="646331"/>
            <a:ext cx="1359130" cy="137539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0073F71-43E1-447C-AA09-B08769CECEF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351392" y="641306"/>
            <a:ext cx="1480792" cy="139337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8A0E65D-484A-4DF3-8B0C-049489085009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14023" y="630879"/>
            <a:ext cx="1389285" cy="139084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55E0E62-6F96-4AE8-AA8D-69509C53A7E6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32606" y="622502"/>
            <a:ext cx="1259729" cy="138917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076AB06-23C4-4DA4-9AFA-7FF4E276C7B4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32606" y="3426456"/>
            <a:ext cx="1255136" cy="136039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ACABC28-4C52-4D55-9D5D-D50DDAB564AD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10718" y="3432840"/>
            <a:ext cx="1387524" cy="136039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D63A705-DC47-4639-8DE7-C5BDB19D9C58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338257" y="3426455"/>
            <a:ext cx="1488528" cy="135865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00FB51D-F967-4C4B-ABA5-4E7F5A19FE69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64777" y="3426457"/>
            <a:ext cx="1359130" cy="1358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6985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2:37Z</dcterms:created>
  <dcterms:modified xsi:type="dcterms:W3CDTF">2020-08-22T04:23:11Z</dcterms:modified>
</cp:coreProperties>
</file>